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53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0224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3968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32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31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652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749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62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75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796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552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75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797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D876EA8-F693-4F9A-8BAE-EE7280E8D5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00" y="247997"/>
            <a:ext cx="6578600" cy="488455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982664E-6E4C-494D-A20E-51B683B3D109}"/>
              </a:ext>
            </a:extLst>
          </p:cNvPr>
          <p:cNvSpPr txBox="1"/>
          <p:nvPr/>
        </p:nvSpPr>
        <p:spPr>
          <a:xfrm>
            <a:off x="139700" y="5461000"/>
            <a:ext cx="65786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800" b="1" ker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5</a:t>
            </a: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atter plots show the correlation between genes with significant differences in high- and low- risk groups and survival time. Blue for low- risk group and red for high- risk group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7832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涵</dc:creator>
  <cp:lastModifiedBy>MDPI</cp:lastModifiedBy>
  <cp:revision>3</cp:revision>
  <dcterms:created xsi:type="dcterms:W3CDTF">2022-05-01T05:12:34Z</dcterms:created>
  <dcterms:modified xsi:type="dcterms:W3CDTF">2022-08-30T11:10:33Z</dcterms:modified>
</cp:coreProperties>
</file>